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696" y="60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 discriminant analysis (LDA) effect size method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ccording to type of sample and time-point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B684C7F7-B424-4A9F-AB88-A66C7E5910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1876174"/>
              </p:ext>
            </p:extLst>
          </p:nvPr>
        </p:nvGraphicFramePr>
        <p:xfrm>
          <a:off x="2818368" y="783511"/>
          <a:ext cx="6553676" cy="5959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10" r:id="rId3" imgW="7728152" imgH="7028120" progId="Prism10.Document">
                  <p:embed/>
                </p:oleObj>
              </mc:Choice>
              <mc:Fallback>
                <p:oleObj name="Prism 10" r:id="rId3" imgW="7728152" imgH="702812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18368" y="783511"/>
                        <a:ext cx="6553676" cy="59599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2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ism 10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20</cp:revision>
  <dcterms:created xsi:type="dcterms:W3CDTF">2022-03-15T12:01:40Z</dcterms:created>
  <dcterms:modified xsi:type="dcterms:W3CDTF">2024-05-02T13:20:11Z</dcterms:modified>
</cp:coreProperties>
</file>